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1717F0-CE1B-4EB1-849F-15E63EE8FA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66D80-9F8F-45A3-B112-B7AC43AA7E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C14477-C1C3-468E-8E23-7730C0DF8D7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77E662-5D59-4D63-BC70-41DFF1F21C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AE7794-84E6-4E3C-BEBD-C0C8162BC7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9CBF74-464B-415E-8DF7-2B357664D1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D3BB33-6EDE-4C39-BE2B-1D353AEAD4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28274-A61B-490E-981B-7577A52CA0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B75F32-851B-44D6-860E-09225AE0F7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8330AC-4C5D-4716-B548-B580E14784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D04CD4-6B66-4676-B5A8-08ACBFD61C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1E41D7-C079-43E7-BAF2-3C2383C40B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80FEF6-BA9D-47E7-B91E-F1481871EF9C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39640" y="5408280"/>
            <a:ext cx="813600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Supplemental Figure 2. The expression consistency between selected tissue-specific genes identified from our microarray data (a) and corresponding ESTs (b).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Most ESTs representing tissue-specific genes identified by whole-genome microarray analysis were also specifically detected in corresponding silkworm tissue typ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843280" y="4869000"/>
            <a:ext cx="64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905440" y="4862520"/>
            <a:ext cx="64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rcRect l="32605" t="13735" r="21691" b="27365"/>
          <a:stretch/>
        </p:blipFill>
        <p:spPr>
          <a:xfrm>
            <a:off x="1908000" y="404640"/>
            <a:ext cx="2400480" cy="439128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2"/>
          <a:srcRect l="34720" t="15341" r="21881" b="29100"/>
          <a:stretch/>
        </p:blipFill>
        <p:spPr>
          <a:xfrm>
            <a:off x="5084640" y="495360"/>
            <a:ext cx="2295720" cy="424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17T14:58:36Z</dcterms:created>
  <dc:creator>番茄花园</dc:creator>
  <dc:description/>
  <dc:language>en-US</dc:language>
  <cp:lastModifiedBy>chengdj</cp:lastModifiedBy>
  <dcterms:modified xsi:type="dcterms:W3CDTF">2007-06-18T14:49:58Z</dcterms:modified>
  <cp:revision>11</cp:revision>
  <dc:subject/>
  <dc:title>幻灯片 1</dc:title>
</cp:coreProperties>
</file>